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4627" autoAdjust="0"/>
  </p:normalViewPr>
  <p:slideViewPr>
    <p:cSldViewPr>
      <p:cViewPr>
        <p:scale>
          <a:sx n="100" d="100"/>
          <a:sy n="100" d="100"/>
        </p:scale>
        <p:origin x="-216" y="46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FD5A6C7-B9F5-4218-8944-21844EC3161B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E133A2-03D5-4E2F-8B12-13D501DF47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36501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6E133A2-03D5-4E2F-8B12-13D501DF4793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92558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3-9-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Rectangle 993"/>
          <p:cNvSpPr>
            <a:spLocks noGrp="1" noChangeArrowheads="1"/>
          </p:cNvSpPr>
          <p:nvPr>
            <p:ph type="title"/>
          </p:nvPr>
        </p:nvSpPr>
        <p:spPr>
          <a:xfrm>
            <a:off x="1042988" y="908720"/>
            <a:ext cx="6265862" cy="217488"/>
          </a:xfrm>
        </p:spPr>
        <p:txBody>
          <a:bodyPr>
            <a:normAutofit fontScale="90000"/>
          </a:bodyPr>
          <a:lstStyle/>
          <a:p>
            <a:pPr algn="l"/>
            <a:r>
              <a:rPr lang="zh-CN" altLang="zh-CN" sz="1000" b="1" dirty="0" smtClean="0">
                <a:latin typeface="Arial" pitchFamily="34" charset="0"/>
                <a:cs typeface="Arial" pitchFamily="34" charset="0"/>
              </a:rPr>
              <a:t>Table S1</a:t>
            </a:r>
            <a:r>
              <a:rPr lang="zh-CN" altLang="zh-CN" sz="1000" dirty="0" smtClean="0">
                <a:latin typeface="Arial" pitchFamily="34" charset="0"/>
                <a:cs typeface="Arial" pitchFamily="34" charset="0"/>
              </a:rPr>
              <a:t>. Hexose yield (% cellulose) released from enzymatic hydrolysis after pretreatment</a:t>
            </a:r>
          </a:p>
        </p:txBody>
      </p:sp>
      <p:graphicFrame>
        <p:nvGraphicFramePr>
          <p:cNvPr id="5501" name="Group 38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32918189"/>
              </p:ext>
            </p:extLst>
          </p:nvPr>
        </p:nvGraphicFramePr>
        <p:xfrm>
          <a:off x="1116013" y="1146725"/>
          <a:ext cx="6767512" cy="3902507"/>
        </p:xfrm>
        <a:graphic>
          <a:graphicData uri="http://schemas.openxmlformats.org/drawingml/2006/table">
            <a:tbl>
              <a:tblPr/>
              <a:tblGrid>
                <a:gridCol w="503237"/>
                <a:gridCol w="600075"/>
                <a:gridCol w="560388"/>
                <a:gridCol w="311150"/>
                <a:gridCol w="539750"/>
                <a:gridCol w="331787"/>
                <a:gridCol w="520700"/>
                <a:gridCol w="350838"/>
                <a:gridCol w="434975"/>
                <a:gridCol w="546100"/>
                <a:gridCol w="325437"/>
                <a:gridCol w="571500"/>
                <a:gridCol w="300038"/>
                <a:gridCol w="527050"/>
                <a:gridCol w="344487"/>
              </a:tblGrid>
              <a:tr h="50027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Pair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Sample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6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NaOH</a:t>
                      </a:r>
                      <a:r>
                        <a:rPr kumimoji="0" lang="en-US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　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en-US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　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6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H</a:t>
                      </a:r>
                      <a:r>
                        <a:rPr kumimoji="0" lang="en-US" altLang="zh-CN" sz="800" b="1" i="0" u="none" strike="noStrike" cap="none" normalizeH="0" baseline="-2500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2</a:t>
                      </a:r>
                      <a:r>
                        <a:rPr kumimoji="0" lang="en-US" altLang="zh-CN" sz="8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SO</a:t>
                      </a:r>
                      <a:r>
                        <a:rPr kumimoji="0" lang="en-US" altLang="zh-CN" sz="800" b="1" i="0" u="none" strike="noStrike" cap="none" normalizeH="0" baseline="-2500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</a:t>
                      </a:r>
                      <a:endParaRPr kumimoji="0" lang="en-US" altLang="zh-CN" sz="8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51207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0.5%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%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%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　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0.25%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%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%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22227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I-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TaLq27(H)</a:t>
                      </a:r>
                      <a:r>
                        <a:rPr kumimoji="0" lang="en-US" altLang="zh-CN" sz="1200" b="1" i="0" u="none" strike="noStrike" cap="none" normalizeH="0" baseline="3000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&amp;</a:t>
                      </a:r>
                      <a:endParaRPr kumimoji="0" lang="en-US" altLang="zh-CN" sz="12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39.2±1.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3</a:t>
                      </a:r>
                      <a:r>
                        <a:rPr kumimoji="0" lang="en-US" altLang="zh-CN" sz="1200" b="1" i="0" u="none" strike="noStrike" cap="none" normalizeH="0" baseline="3000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@ 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1.7±3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8.0±1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zh-CN" altLang="en-US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　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35.7±1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0.3±1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0.4±1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8288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TaLq98(L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29.5±0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31.4±1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3.1±2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21.7±0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34.3±0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33.6±0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22227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27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I-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TaLq1(H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2.3±0.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4.5±2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5.4±1.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33.1±0.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8.4±1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1.0±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27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TaLq47(L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26.9±1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33.8±1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1.6±0.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23.8±0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35.8±0.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34.2±1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22227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27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I-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TaLq107(H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8.9±1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2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2.7±2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67.0±1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32.2±1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7.6±1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7.3±0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27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TaLq93(L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24.4±0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35.3±2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37.7±0.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22.6±0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34.4±0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28.0±1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22227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27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27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II-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TaLq1(H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2.3±0.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4.5±2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5.4±1.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33.1±0.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8.4±1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1.0±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27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TaLq71(L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28.7±0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32.0±1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7.5±1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26.3±0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2.5±0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36.4±1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22227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27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II-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TaLq107(H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8.9±1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2.7±2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67.0±1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32.2±1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7.6±1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7.3±0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27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TaLq58(L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38.6±1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38.3±1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0.3±2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30.5±0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4.6±1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36.6±0.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22227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27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II-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TaLq46(H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38.7±0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6.8±0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2.1±1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,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29.7±0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3.4±0.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0.8±1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27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TaLq47(L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26.9±1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33.8±1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1.6±0.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23.8±0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35.8±0.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34.2±1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22227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1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27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27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III-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Osfc27</a:t>
                      </a: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(H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5.7±1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9.6±6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79.7±2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5.3±1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2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8.4±2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5.4±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27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TaLq71(L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28.7±0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32.0±1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7.5±1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26.3±0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2.5±0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36.4±1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22227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27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III-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Osfc2</a:t>
                      </a: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(H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61.1±2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93.4±4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00.0±1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1.2±1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61.6±1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65.4±3.2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4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27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TaLq85(L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1.0±0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1.3±1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8.1±1.8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31.6±1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9.4±2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7.1±0.6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122227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07945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1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III-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Osfc32</a:t>
                      </a: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(H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1.2±0.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67.4±1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00.0±1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4.8±0.3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74.3±2.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68.3±2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1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122227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TaLq27(L)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39.2±1.9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1.7±3.0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8.0±1.7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zh-CN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宋体" pitchFamily="2" charset="-122"/>
                        <a:cs typeface="Arial" charset="0"/>
                      </a:endParaRP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35.7±1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50.3±1.5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zh-CN" sz="8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宋体" pitchFamily="2" charset="-122"/>
                          <a:cs typeface="Arial" charset="0"/>
                        </a:rPr>
                        <a:t>40.4±1.1</a:t>
                      </a:r>
                    </a:p>
                  </a:txBody>
                  <a:tcPr marL="0" marR="0" marT="0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5498" name="Rectangle 994"/>
          <p:cNvSpPr>
            <a:spLocks noChangeArrowheads="1"/>
          </p:cNvSpPr>
          <p:nvPr/>
        </p:nvSpPr>
        <p:spPr bwMode="auto">
          <a:xfrm>
            <a:off x="1042988" y="5048349"/>
            <a:ext cx="6697662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GB" altLang="en-US" sz="1200" b="1" baseline="30000" dirty="0">
                <a:latin typeface="Arial" pitchFamily="34" charset="0"/>
                <a:cs typeface="Arial" pitchFamily="34" charset="0"/>
                <a:sym typeface="宋体" pitchFamily="2" charset="-122"/>
              </a:rPr>
              <a:t>&amp;</a:t>
            </a:r>
            <a:r>
              <a:rPr lang="en-US" altLang="zh-CN" sz="1000" baseline="0" dirty="0">
                <a:cs typeface="Arial" charset="0"/>
                <a:sym typeface="宋体" pitchFamily="2" charset="-122"/>
              </a:rPr>
              <a:t>,</a:t>
            </a:r>
            <a:r>
              <a:rPr lang="zh-CN" altLang="en-US" sz="1000" baseline="0" dirty="0">
                <a:cs typeface="Arial" charset="0"/>
                <a:sym typeface="宋体" pitchFamily="2" charset="-122"/>
              </a:rPr>
              <a:t> </a:t>
            </a:r>
            <a:r>
              <a:rPr lang="zh-CN" altLang="en-US" sz="1000" baseline="0" dirty="0" smtClean="0">
                <a:cs typeface="Arial" charset="0"/>
                <a:sym typeface="宋体" pitchFamily="2" charset="-122"/>
              </a:rPr>
              <a:t> </a:t>
            </a:r>
            <a:r>
              <a:rPr lang="zh-CN" altLang="en-US" sz="1000" baseline="0" dirty="0" smtClean="0">
                <a:latin typeface="Arial" pitchFamily="34" charset="0"/>
                <a:cs typeface="Arial" pitchFamily="34" charset="0"/>
                <a:sym typeface="宋体" pitchFamily="2" charset="-122"/>
              </a:rPr>
              <a:t>(</a:t>
            </a:r>
            <a:r>
              <a:rPr lang="zh-CN" altLang="en-US" sz="1000" baseline="0" dirty="0">
                <a:latin typeface="Arial" pitchFamily="34" charset="0"/>
                <a:cs typeface="Arial" pitchFamily="34" charset="0"/>
                <a:sym typeface="宋体" pitchFamily="2" charset="-122"/>
              </a:rPr>
              <a:t>H) or (L) Indicated the sample in the pair with </a:t>
            </a:r>
            <a:r>
              <a:rPr lang="en-US" altLang="zh-CN" sz="1000" baseline="0" dirty="0">
                <a:latin typeface="Arial" pitchFamily="34" charset="0"/>
                <a:cs typeface="Arial" pitchFamily="34" charset="0"/>
                <a:sym typeface="宋体" pitchFamily="2" charset="-122"/>
              </a:rPr>
              <a:t>relatively high (H) or low (L)  biomass digestibility;</a:t>
            </a:r>
            <a:endParaRPr lang="zh-CN" altLang="en-US" sz="1000" baseline="0" dirty="0">
              <a:latin typeface="Arial" pitchFamily="34" charset="0"/>
              <a:cs typeface="Arial" pitchFamily="34" charset="0"/>
              <a:sym typeface="宋体" pitchFamily="2" charset="-122"/>
            </a:endParaRPr>
          </a:p>
          <a:p>
            <a:r>
              <a:rPr lang="en-US" altLang="zh-CN" sz="1200" b="1" baseline="30000" dirty="0">
                <a:latin typeface="Arial" pitchFamily="34" charset="0"/>
                <a:cs typeface="Arial" pitchFamily="34" charset="0"/>
              </a:rPr>
              <a:t>@</a:t>
            </a:r>
            <a:r>
              <a:rPr lang="en-US" altLang="zh-CN" sz="1000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,</a:t>
            </a:r>
            <a:r>
              <a:rPr lang="zh-CN" altLang="en-US" sz="1000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GB" altLang="en-US" sz="1000" baseline="0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Ratio of two sample values at pair.</a:t>
            </a:r>
          </a:p>
        </p:txBody>
      </p:sp>
    </p:spTree>
    <p:extLst>
      <p:ext uri="{BB962C8B-B14F-4D97-AF65-F5344CB8AC3E}">
        <p14:creationId xmlns:p14="http://schemas.microsoft.com/office/powerpoint/2010/main" val="39065395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78</Words>
  <Application>Microsoft Office PowerPoint</Application>
  <PresentationFormat>全屏显示(4:3)</PresentationFormat>
  <Paragraphs>206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Table S1. Hexose yield (% cellulose) released from enzymatic hydrolysis after pretreatme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able S1. Hexose yield (% cellulose) released from enzymatic hydrolysis after pretreatment</dc:title>
  <cp:lastModifiedBy>微软用户</cp:lastModifiedBy>
  <cp:revision>4</cp:revision>
  <dcterms:modified xsi:type="dcterms:W3CDTF">2013-09-04T07:13:02Z</dcterms:modified>
</cp:coreProperties>
</file>